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00" r:id="rId5"/>
  </p:sldIdLst>
  <p:sldSz cx="9601200" cy="12801600" type="A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97" autoAdjust="0"/>
    <p:restoredTop sz="94660"/>
  </p:normalViewPr>
  <p:slideViewPr>
    <p:cSldViewPr snapToGrid="0">
      <p:cViewPr>
        <p:scale>
          <a:sx n="125" d="100"/>
          <a:sy n="125" d="100"/>
        </p:scale>
        <p:origin x="510" y="-1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西田　健太朗" userId="bc94bac3-4cb4-4747-a4e6-674ef9948a55" providerId="ADAL" clId="{6709D6C8-D299-463F-91F2-BE72652812B4}"/>
    <pc:docChg chg="delSld modSld">
      <pc:chgData name="西田　健太朗" userId="bc94bac3-4cb4-4747-a4e6-674ef9948a55" providerId="ADAL" clId="{6709D6C8-D299-463F-91F2-BE72652812B4}" dt="2026-01-09T05:34:33.489" v="19" actId="255"/>
      <pc:docMkLst>
        <pc:docMk/>
      </pc:docMkLst>
      <pc:sldChg chg="del">
        <pc:chgData name="西田　健太朗" userId="bc94bac3-4cb4-4747-a4e6-674ef9948a55" providerId="ADAL" clId="{6709D6C8-D299-463F-91F2-BE72652812B4}" dt="2026-01-08T08:39:54.177" v="0" actId="2696"/>
        <pc:sldMkLst>
          <pc:docMk/>
          <pc:sldMk cId="3852982278" sldId="298"/>
        </pc:sldMkLst>
      </pc:sldChg>
      <pc:sldChg chg="del">
        <pc:chgData name="西田　健太朗" userId="bc94bac3-4cb4-4747-a4e6-674ef9948a55" providerId="ADAL" clId="{6709D6C8-D299-463F-91F2-BE72652812B4}" dt="2026-01-08T08:39:54.177" v="0" actId="2696"/>
        <pc:sldMkLst>
          <pc:docMk/>
          <pc:sldMk cId="116731960" sldId="299"/>
        </pc:sldMkLst>
      </pc:sldChg>
      <pc:sldChg chg="modSp mod">
        <pc:chgData name="西田　健太朗" userId="bc94bac3-4cb4-4747-a4e6-674ef9948a55" providerId="ADAL" clId="{6709D6C8-D299-463F-91F2-BE72652812B4}" dt="2026-01-09T05:34:33.489" v="19" actId="255"/>
        <pc:sldMkLst>
          <pc:docMk/>
          <pc:sldMk cId="3918428493" sldId="300"/>
        </pc:sldMkLst>
        <pc:spChg chg="mod">
          <ac:chgData name="西田　健太朗" userId="bc94bac3-4cb4-4747-a4e6-674ef9948a55" providerId="ADAL" clId="{6709D6C8-D299-463F-91F2-BE72652812B4}" dt="2026-01-09T05:34:14.137" v="18" actId="1076"/>
          <ac:spMkLst>
            <pc:docMk/>
            <pc:sldMk cId="3918428493" sldId="300"/>
            <ac:spMk id="4" creationId="{5C449A6B-6771-9727-2FFA-1C0EA4D183A6}"/>
          </ac:spMkLst>
        </pc:spChg>
        <pc:spChg chg="mod">
          <ac:chgData name="西田　健太朗" userId="bc94bac3-4cb4-4747-a4e6-674ef9948a55" providerId="ADAL" clId="{6709D6C8-D299-463F-91F2-BE72652812B4}" dt="2026-01-09T05:34:33.489" v="19" actId="255"/>
          <ac:spMkLst>
            <pc:docMk/>
            <pc:sldMk cId="3918428493" sldId="300"/>
            <ac:spMk id="7" creationId="{56BA9D68-01C6-729D-90B0-626A71AE4E44}"/>
          </ac:spMkLst>
        </pc:spChg>
        <pc:spChg chg="mod">
          <ac:chgData name="西田　健太朗" userId="bc94bac3-4cb4-4747-a4e6-674ef9948a55" providerId="ADAL" clId="{6709D6C8-D299-463F-91F2-BE72652812B4}" dt="2026-01-09T05:34:33.489" v="19" actId="255"/>
          <ac:spMkLst>
            <pc:docMk/>
            <pc:sldMk cId="3918428493" sldId="300"/>
            <ac:spMk id="45" creationId="{0A72D36C-B472-0427-0E02-EADECFD22F97}"/>
          </ac:spMkLst>
        </pc:spChg>
        <pc:spChg chg="mod">
          <ac:chgData name="西田　健太朗" userId="bc94bac3-4cb4-4747-a4e6-674ef9948a55" providerId="ADAL" clId="{6709D6C8-D299-463F-91F2-BE72652812B4}" dt="2026-01-09T05:31:58.971" v="16" actId="6549"/>
          <ac:spMkLst>
            <pc:docMk/>
            <pc:sldMk cId="3918428493" sldId="300"/>
            <ac:spMk id="114" creationId="{15324B79-35AF-B012-7B8D-E1C8E0D3804E}"/>
          </ac:spMkLst>
        </pc:spChg>
        <pc:picChg chg="mod">
          <ac:chgData name="西田　健太朗" userId="bc94bac3-4cb4-4747-a4e6-674ef9948a55" providerId="ADAL" clId="{6709D6C8-D299-463F-91F2-BE72652812B4}" dt="2026-01-09T05:33:24.480" v="17" actId="692"/>
          <ac:picMkLst>
            <pc:docMk/>
            <pc:sldMk cId="3918428493" sldId="300"/>
            <ac:picMk id="13" creationId="{74C6D06E-3D36-9D04-C0B9-279FF83173C5}"/>
          </ac:picMkLst>
        </pc:picChg>
        <pc:picChg chg="mod">
          <ac:chgData name="西田　健太朗" userId="bc94bac3-4cb4-4747-a4e6-674ef9948a55" providerId="ADAL" clId="{6709D6C8-D299-463F-91F2-BE72652812B4}" dt="2026-01-09T05:33:24.480" v="17" actId="692"/>
          <ac:picMkLst>
            <pc:docMk/>
            <pc:sldMk cId="3918428493" sldId="300"/>
            <ac:picMk id="26" creationId="{B1734356-B909-5746-FB29-BE91A0B1D11E}"/>
          </ac:picMkLst>
        </pc:picChg>
      </pc:sldChg>
      <pc:sldChg chg="del">
        <pc:chgData name="西田　健太朗" userId="bc94bac3-4cb4-4747-a4e6-674ef9948a55" providerId="ADAL" clId="{6709D6C8-D299-463F-91F2-BE72652812B4}" dt="2026-01-08T08:39:54.177" v="0" actId="2696"/>
        <pc:sldMkLst>
          <pc:docMk/>
          <pc:sldMk cId="1081936292" sldId="301"/>
        </pc:sldMkLst>
      </pc:sldChg>
      <pc:sldChg chg="del">
        <pc:chgData name="西田　健太朗" userId="bc94bac3-4cb4-4747-a4e6-674ef9948a55" providerId="ADAL" clId="{6709D6C8-D299-463F-91F2-BE72652812B4}" dt="2026-01-08T08:39:54.177" v="0" actId="2696"/>
        <pc:sldMkLst>
          <pc:docMk/>
          <pc:sldMk cId="1594321563" sldId="30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619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940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089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649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889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725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397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013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9166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269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764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681484-7D66-6E24-BE52-52FB5589FC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A72D36C-B472-0427-0E02-EADECFD22F97}"/>
              </a:ext>
            </a:extLst>
          </p:cNvPr>
          <p:cNvSpPr txBox="1"/>
          <p:nvPr/>
        </p:nvSpPr>
        <p:spPr>
          <a:xfrm>
            <a:off x="1614528" y="3641855"/>
            <a:ext cx="3513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90840">
              <a:defRPr/>
            </a:pPr>
            <a:r>
              <a:rPr kumimoji="1"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en-US" altLang="ja-JP" sz="2400" dirty="0">
              <a:solidFill>
                <a:prstClr val="black"/>
              </a:solidFill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15324B79-35AF-B012-7B8D-E1C8E0D3804E}"/>
              </a:ext>
            </a:extLst>
          </p:cNvPr>
          <p:cNvSpPr txBox="1"/>
          <p:nvPr/>
        </p:nvSpPr>
        <p:spPr>
          <a:xfrm rot="16200000">
            <a:off x="1184938" y="7251772"/>
            <a:ext cx="2296784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opo II</a:t>
            </a:r>
            <a:r>
              <a:rPr kumimoji="1" lang="el-GR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</a:t>
            </a:r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expression levels </a:t>
            </a:r>
          </a:p>
          <a:p>
            <a:pPr algn="ctr"/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.u</a:t>
            </a:r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.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56BA9D68-01C6-729D-90B0-626A71AE4E44}"/>
              </a:ext>
            </a:extLst>
          </p:cNvPr>
          <p:cNvSpPr/>
          <p:nvPr/>
        </p:nvSpPr>
        <p:spPr>
          <a:xfrm>
            <a:off x="1614528" y="6297440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</a:t>
            </a:r>
            <a:endParaRPr lang="ja-JP" altLang="en-US" sz="2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C449A6B-6771-9727-2FFA-1C0EA4D183A6}"/>
              </a:ext>
            </a:extLst>
          </p:cNvPr>
          <p:cNvSpPr txBox="1"/>
          <p:nvPr/>
        </p:nvSpPr>
        <p:spPr>
          <a:xfrm>
            <a:off x="189152" y="120602"/>
            <a:ext cx="42883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Supplemental</a:t>
            </a:r>
            <a:r>
              <a:rPr kumimoji="1" lang="ja-JP" altLang="en-US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Fig.</a:t>
            </a:r>
            <a:r>
              <a:rPr kumimoji="1" lang="ja-JP" altLang="en-US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3</a:t>
            </a:r>
          </a:p>
        </p:txBody>
      </p:sp>
      <p:pic>
        <p:nvPicPr>
          <p:cNvPr id="13" name="図 12" descr="パソコンの画面&#10;&#10;中程度の精度で自動的に生成された説明">
            <a:extLst>
              <a:ext uri="{FF2B5EF4-FFF2-40B4-BE49-F238E27FC236}">
                <a16:creationId xmlns:a16="http://schemas.microsoft.com/office/drawing/2014/main" id="{74C6D06E-3D36-9D04-C0B9-279FF83173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778" t="18753" r="8793" b="74379"/>
          <a:stretch/>
        </p:blipFill>
        <p:spPr>
          <a:xfrm>
            <a:off x="2985967" y="4644720"/>
            <a:ext cx="5020202" cy="6217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" name="図 25" descr="煙, 長い, 空気, グループ が含まれている画像&#10;&#10;自動的に生成された説明">
            <a:extLst>
              <a:ext uri="{FF2B5EF4-FFF2-40B4-BE49-F238E27FC236}">
                <a16:creationId xmlns:a16="http://schemas.microsoft.com/office/drawing/2014/main" id="{B1734356-B909-5746-FB29-BE91A0B1D11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98" t="62227" r="9290" b="30909"/>
          <a:stretch/>
        </p:blipFill>
        <p:spPr>
          <a:xfrm>
            <a:off x="2985945" y="5346452"/>
            <a:ext cx="5018141" cy="6214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8395376-4652-75B5-A003-93FA12581C69}"/>
              </a:ext>
            </a:extLst>
          </p:cNvPr>
          <p:cNvSpPr txBox="1"/>
          <p:nvPr/>
        </p:nvSpPr>
        <p:spPr>
          <a:xfrm rot="19272057">
            <a:off x="2859570" y="4083150"/>
            <a:ext cx="1136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A9A4196-511E-7B96-FB37-EF260017C0D1}"/>
              </a:ext>
            </a:extLst>
          </p:cNvPr>
          <p:cNvSpPr txBox="1"/>
          <p:nvPr/>
        </p:nvSpPr>
        <p:spPr>
          <a:xfrm flipH="1">
            <a:off x="5274035" y="4262094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A8A7C5C-D831-B157-ED09-AD957D5B407B}"/>
              </a:ext>
            </a:extLst>
          </p:cNvPr>
          <p:cNvSpPr txBox="1"/>
          <p:nvPr/>
        </p:nvSpPr>
        <p:spPr>
          <a:xfrm>
            <a:off x="3913462" y="4262094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B07373CC-1FB6-7BA1-85A8-1FABFA52846B}"/>
              </a:ext>
            </a:extLst>
          </p:cNvPr>
          <p:cNvSpPr txBox="1"/>
          <p:nvPr/>
        </p:nvSpPr>
        <p:spPr>
          <a:xfrm>
            <a:off x="4617832" y="4262094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05B2A36A-C55B-5428-4401-99FE579494DB}"/>
              </a:ext>
            </a:extLst>
          </p:cNvPr>
          <p:cNvCxnSpPr>
            <a:cxnSpLocks/>
          </p:cNvCxnSpPr>
          <p:nvPr/>
        </p:nvCxnSpPr>
        <p:spPr>
          <a:xfrm>
            <a:off x="3953457" y="4223164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F8389439-B655-2089-F7FE-A074219684B4}"/>
              </a:ext>
            </a:extLst>
          </p:cNvPr>
          <p:cNvSpPr/>
          <p:nvPr/>
        </p:nvSpPr>
        <p:spPr>
          <a:xfrm>
            <a:off x="3807812" y="3898735"/>
            <a:ext cx="217239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XZ (mg/kg) for 48 h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CE2B4B6-7432-B34B-9C35-52DE790DE346}"/>
              </a:ext>
            </a:extLst>
          </p:cNvPr>
          <p:cNvSpPr txBox="1"/>
          <p:nvPr/>
        </p:nvSpPr>
        <p:spPr>
          <a:xfrm flipH="1">
            <a:off x="7333750" y="4262287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D25CF40-0426-D228-D39F-B01BE6B8100C}"/>
              </a:ext>
            </a:extLst>
          </p:cNvPr>
          <p:cNvSpPr txBox="1"/>
          <p:nvPr/>
        </p:nvSpPr>
        <p:spPr>
          <a:xfrm>
            <a:off x="5947050" y="4262287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EDB9566-8FF1-2B41-9E07-C3B31CACBD9D}"/>
              </a:ext>
            </a:extLst>
          </p:cNvPr>
          <p:cNvSpPr txBox="1"/>
          <p:nvPr/>
        </p:nvSpPr>
        <p:spPr>
          <a:xfrm>
            <a:off x="6660129" y="4262287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782E64D9-6A69-7317-5202-1FF05701C7E5}"/>
              </a:ext>
            </a:extLst>
          </p:cNvPr>
          <p:cNvCxnSpPr>
            <a:cxnSpLocks/>
          </p:cNvCxnSpPr>
          <p:nvPr/>
        </p:nvCxnSpPr>
        <p:spPr>
          <a:xfrm>
            <a:off x="3953457" y="4223357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6EF3469B-6C9C-F062-D883-792B576F3B81}"/>
              </a:ext>
            </a:extLst>
          </p:cNvPr>
          <p:cNvSpPr/>
          <p:nvPr/>
        </p:nvSpPr>
        <p:spPr>
          <a:xfrm>
            <a:off x="5823848" y="3898735"/>
            <a:ext cx="21034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XZ (mg/kg) for 72 h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5392D265-EEF0-D594-1A3E-79BFC1C4187B}"/>
              </a:ext>
            </a:extLst>
          </p:cNvPr>
          <p:cNvCxnSpPr>
            <a:cxnSpLocks/>
          </p:cNvCxnSpPr>
          <p:nvPr/>
        </p:nvCxnSpPr>
        <p:spPr>
          <a:xfrm>
            <a:off x="5969494" y="4227707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CA52905A-B778-EB23-9A16-73AB67DE2AB2}"/>
              </a:ext>
            </a:extLst>
          </p:cNvPr>
          <p:cNvCxnSpPr>
            <a:cxnSpLocks/>
          </p:cNvCxnSpPr>
          <p:nvPr/>
        </p:nvCxnSpPr>
        <p:spPr>
          <a:xfrm>
            <a:off x="3141595" y="3853084"/>
            <a:ext cx="470030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D55976B-C6AF-76B0-59F8-F74F921B5B19}"/>
              </a:ext>
            </a:extLst>
          </p:cNvPr>
          <p:cNvSpPr txBox="1"/>
          <p:nvPr/>
        </p:nvSpPr>
        <p:spPr>
          <a:xfrm>
            <a:off x="5234281" y="3559989"/>
            <a:ext cx="7933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lang="ja-JP" altLang="en-US" sz="1600" dirty="0"/>
          </a:p>
        </p:txBody>
      </p:sp>
      <p:pic>
        <p:nvPicPr>
          <p:cNvPr id="37" name="図 36">
            <a:extLst>
              <a:ext uri="{FF2B5EF4-FFF2-40B4-BE49-F238E27FC236}">
                <a16:creationId xmlns:a16="http://schemas.microsoft.com/office/drawing/2014/main" id="{71A6847B-829B-ACDF-3CB7-0D0D4EAC8018}"/>
              </a:ext>
            </a:extLst>
          </p:cNvPr>
          <p:cNvPicPr>
            <a:picLocks/>
          </p:cNvPicPr>
          <p:nvPr/>
        </p:nvPicPr>
        <p:blipFill>
          <a:blip r:embed="rId4"/>
          <a:srcRect l="4912" b="16280"/>
          <a:stretch/>
        </p:blipFill>
        <p:spPr>
          <a:xfrm>
            <a:off x="2928338" y="6336016"/>
            <a:ext cx="5066315" cy="2296784"/>
          </a:xfrm>
          <a:prstGeom prst="rect">
            <a:avLst/>
          </a:prstGeom>
        </p:spPr>
      </p:pic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DD567BD-0A30-A6D6-414A-338299B0654B}"/>
              </a:ext>
            </a:extLst>
          </p:cNvPr>
          <p:cNvGrpSpPr/>
          <p:nvPr/>
        </p:nvGrpSpPr>
        <p:grpSpPr>
          <a:xfrm>
            <a:off x="8044088" y="4953144"/>
            <a:ext cx="702681" cy="338554"/>
            <a:chOff x="3388623" y="4387335"/>
            <a:chExt cx="772949" cy="338554"/>
          </a:xfrm>
        </p:grpSpPr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85D02E58-FAC5-E8F6-BB01-E1DDE4338DFD}"/>
                </a:ext>
              </a:extLst>
            </p:cNvPr>
            <p:cNvCxnSpPr/>
            <p:nvPr/>
          </p:nvCxnSpPr>
          <p:spPr>
            <a:xfrm>
              <a:off x="3388623" y="4572001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AB228E80-402C-B6CC-2CCF-D0FEE37AC584}"/>
                </a:ext>
              </a:extLst>
            </p:cNvPr>
            <p:cNvSpPr txBox="1"/>
            <p:nvPr/>
          </p:nvSpPr>
          <p:spPr>
            <a:xfrm>
              <a:off x="3635466" y="4387335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05F06529-2ACF-FB6D-4013-C0BE793FAD6C}"/>
              </a:ext>
            </a:extLst>
          </p:cNvPr>
          <p:cNvGrpSpPr/>
          <p:nvPr/>
        </p:nvGrpSpPr>
        <p:grpSpPr>
          <a:xfrm>
            <a:off x="8044088" y="4517718"/>
            <a:ext cx="702681" cy="338554"/>
            <a:chOff x="3402124" y="3657992"/>
            <a:chExt cx="772949" cy="338554"/>
          </a:xfrm>
        </p:grpSpPr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24FBE08B-FE1A-3A35-43B2-EDB59F9BC2C1}"/>
                </a:ext>
              </a:extLst>
            </p:cNvPr>
            <p:cNvCxnSpPr/>
            <p:nvPr/>
          </p:nvCxnSpPr>
          <p:spPr>
            <a:xfrm>
              <a:off x="3402124" y="3842658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67D49CC-2334-786F-0F91-F264FEA313A9}"/>
                </a:ext>
              </a:extLst>
            </p:cNvPr>
            <p:cNvSpPr txBox="1"/>
            <p:nvPr/>
          </p:nvSpPr>
          <p:spPr>
            <a:xfrm>
              <a:off x="3648967" y="3657992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F5660854-B578-7B43-12AE-F839BACA817A}"/>
              </a:ext>
            </a:extLst>
          </p:cNvPr>
          <p:cNvGrpSpPr/>
          <p:nvPr/>
        </p:nvGrpSpPr>
        <p:grpSpPr>
          <a:xfrm>
            <a:off x="8038914" y="5282835"/>
            <a:ext cx="599214" cy="338554"/>
            <a:chOff x="3453696" y="7544499"/>
            <a:chExt cx="659135" cy="338554"/>
          </a:xfrm>
        </p:grpSpPr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8421C540-0EE5-5EF3-60E7-A1B72FBC66F0}"/>
                </a:ext>
              </a:extLst>
            </p:cNvPr>
            <p:cNvCxnSpPr/>
            <p:nvPr/>
          </p:nvCxnSpPr>
          <p:spPr>
            <a:xfrm>
              <a:off x="3453696" y="7729165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10E6371-03C8-CBE5-6163-4D5266E42D8C}"/>
                </a:ext>
              </a:extLst>
            </p:cNvPr>
            <p:cNvSpPr txBox="1"/>
            <p:nvPr/>
          </p:nvSpPr>
          <p:spPr>
            <a:xfrm>
              <a:off x="3700539" y="7544499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27D099AA-DA93-19BA-6CBE-B43FA21C6415}"/>
              </a:ext>
            </a:extLst>
          </p:cNvPr>
          <p:cNvGrpSpPr/>
          <p:nvPr/>
        </p:nvGrpSpPr>
        <p:grpSpPr>
          <a:xfrm>
            <a:off x="8038914" y="5757063"/>
            <a:ext cx="599214" cy="338554"/>
            <a:chOff x="3467197" y="9439312"/>
            <a:chExt cx="659135" cy="338554"/>
          </a:xfrm>
        </p:grpSpPr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898E3CC0-9E4A-26B4-A6C7-1DA009CA305E}"/>
                </a:ext>
              </a:extLst>
            </p:cNvPr>
            <p:cNvCxnSpPr/>
            <p:nvPr/>
          </p:nvCxnSpPr>
          <p:spPr>
            <a:xfrm>
              <a:off x="3467197" y="9623978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65462B78-946C-3820-A03F-6367AFA0A2B4}"/>
                </a:ext>
              </a:extLst>
            </p:cNvPr>
            <p:cNvSpPr txBox="1"/>
            <p:nvPr/>
          </p:nvSpPr>
          <p:spPr>
            <a:xfrm>
              <a:off x="3714040" y="9439312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43144B3-AC92-8662-3406-5291BC21507A}"/>
              </a:ext>
            </a:extLst>
          </p:cNvPr>
          <p:cNvSpPr txBox="1"/>
          <p:nvPr/>
        </p:nvSpPr>
        <p:spPr>
          <a:xfrm>
            <a:off x="8173673" y="4212767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46954C5-3AFF-0E8A-8AE9-ADAAD5A539B1}"/>
              </a:ext>
            </a:extLst>
          </p:cNvPr>
          <p:cNvSpPr txBox="1"/>
          <p:nvPr/>
        </p:nvSpPr>
        <p:spPr>
          <a:xfrm>
            <a:off x="1748589" y="4832268"/>
            <a:ext cx="999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53853"/>
            <a:r>
              <a:rPr kumimoji="1"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opo II</a:t>
            </a:r>
            <a:r>
              <a:rPr kumimoji="1" lang="el-GR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β</a:t>
            </a:r>
            <a:endParaRPr kumimoji="1"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4DB4969-2D0E-5B22-B981-0BB4A6805FCA}"/>
              </a:ext>
            </a:extLst>
          </p:cNvPr>
          <p:cNvSpPr txBox="1"/>
          <p:nvPr/>
        </p:nvSpPr>
        <p:spPr>
          <a:xfrm>
            <a:off x="1902418" y="5459584"/>
            <a:ext cx="861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53853"/>
            <a:r>
              <a:rPr kumimoji="1" lang="el-GR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β</a:t>
            </a:r>
            <a:r>
              <a:rPr kumimoji="1"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0" name="矢印: 右 19">
            <a:extLst>
              <a:ext uri="{FF2B5EF4-FFF2-40B4-BE49-F238E27FC236}">
                <a16:creationId xmlns:a16="http://schemas.microsoft.com/office/drawing/2014/main" id="{0FB72C28-AF8F-FBED-EBC6-C8F1B9EADFC7}"/>
              </a:ext>
            </a:extLst>
          </p:cNvPr>
          <p:cNvSpPr/>
          <p:nvPr/>
        </p:nvSpPr>
        <p:spPr>
          <a:xfrm>
            <a:off x="2703063" y="4933927"/>
            <a:ext cx="225276" cy="146957"/>
          </a:xfrm>
          <a:prstGeom prst="rightArrow">
            <a:avLst>
              <a:gd name="adj1" fmla="val 39629"/>
              <a:gd name="adj2" fmla="val 5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矢印: 右 20">
            <a:extLst>
              <a:ext uri="{FF2B5EF4-FFF2-40B4-BE49-F238E27FC236}">
                <a16:creationId xmlns:a16="http://schemas.microsoft.com/office/drawing/2014/main" id="{6D4A1742-8A1E-C14B-8071-8E20BD9EAD5E}"/>
              </a:ext>
            </a:extLst>
          </p:cNvPr>
          <p:cNvSpPr/>
          <p:nvPr/>
        </p:nvSpPr>
        <p:spPr>
          <a:xfrm>
            <a:off x="2710923" y="5583624"/>
            <a:ext cx="225276" cy="146957"/>
          </a:xfrm>
          <a:prstGeom prst="rightArrow">
            <a:avLst>
              <a:gd name="adj1" fmla="val 39629"/>
              <a:gd name="adj2" fmla="val 5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244680A-AF63-5215-82EA-3AAD17CDB0A6}"/>
              </a:ext>
            </a:extLst>
          </p:cNvPr>
          <p:cNvSpPr txBox="1"/>
          <p:nvPr/>
        </p:nvSpPr>
        <p:spPr>
          <a:xfrm rot="19272057">
            <a:off x="2643277" y="8780775"/>
            <a:ext cx="1136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A3AE7A9-3CA7-22C4-F566-EC0294BCD715}"/>
              </a:ext>
            </a:extLst>
          </p:cNvPr>
          <p:cNvSpPr txBox="1"/>
          <p:nvPr/>
        </p:nvSpPr>
        <p:spPr>
          <a:xfrm flipH="1">
            <a:off x="5188047" y="8611498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39865C3-1BF5-ED32-30FF-EBFA7182BC06}"/>
              </a:ext>
            </a:extLst>
          </p:cNvPr>
          <p:cNvSpPr txBox="1"/>
          <p:nvPr/>
        </p:nvSpPr>
        <p:spPr>
          <a:xfrm>
            <a:off x="3827474" y="8611498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55D5875-504E-E68D-D55B-8EBC190117A5}"/>
              </a:ext>
            </a:extLst>
          </p:cNvPr>
          <p:cNvSpPr txBox="1"/>
          <p:nvPr/>
        </p:nvSpPr>
        <p:spPr>
          <a:xfrm>
            <a:off x="4531844" y="8611498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6C1808E8-CEC6-B27D-55F7-CDEF2694F36E}"/>
              </a:ext>
            </a:extLst>
          </p:cNvPr>
          <p:cNvSpPr/>
          <p:nvPr/>
        </p:nvSpPr>
        <p:spPr>
          <a:xfrm>
            <a:off x="3803184" y="8953098"/>
            <a:ext cx="18549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XZ (mg/kg) for 48 h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901DD47-CBE6-6DA8-2EDD-FAE7C8F7578D}"/>
              </a:ext>
            </a:extLst>
          </p:cNvPr>
          <p:cNvSpPr txBox="1"/>
          <p:nvPr/>
        </p:nvSpPr>
        <p:spPr>
          <a:xfrm flipH="1">
            <a:off x="7298562" y="8611691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12D8B29-07CB-6512-6C37-86531C4698C9}"/>
              </a:ext>
            </a:extLst>
          </p:cNvPr>
          <p:cNvSpPr txBox="1"/>
          <p:nvPr/>
        </p:nvSpPr>
        <p:spPr>
          <a:xfrm>
            <a:off x="5943612" y="8611691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A9179F1-D672-E8E1-475A-B758EA0BE2CB}"/>
              </a:ext>
            </a:extLst>
          </p:cNvPr>
          <p:cNvSpPr txBox="1"/>
          <p:nvPr/>
        </p:nvSpPr>
        <p:spPr>
          <a:xfrm>
            <a:off x="6631291" y="8611691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7095D383-E0BC-8ECC-643C-EDE8C8DC8E27}"/>
              </a:ext>
            </a:extLst>
          </p:cNvPr>
          <p:cNvCxnSpPr>
            <a:cxnSpLocks/>
          </p:cNvCxnSpPr>
          <p:nvPr/>
        </p:nvCxnSpPr>
        <p:spPr>
          <a:xfrm>
            <a:off x="3816707" y="8938438"/>
            <a:ext cx="18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1A4210EA-65D4-D1BC-AFFA-F7A8382DEF60}"/>
              </a:ext>
            </a:extLst>
          </p:cNvPr>
          <p:cNvSpPr/>
          <p:nvPr/>
        </p:nvSpPr>
        <p:spPr>
          <a:xfrm>
            <a:off x="5946220" y="8953098"/>
            <a:ext cx="18549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XZ (mg/kg) for 72 h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F456E819-7EDF-A596-DFCC-F3CB85B610FC}"/>
              </a:ext>
            </a:extLst>
          </p:cNvPr>
          <p:cNvCxnSpPr>
            <a:cxnSpLocks/>
          </p:cNvCxnSpPr>
          <p:nvPr/>
        </p:nvCxnSpPr>
        <p:spPr>
          <a:xfrm>
            <a:off x="5921644" y="8938438"/>
            <a:ext cx="18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1D1A711-C95C-20D3-6BBC-7157D762387C}"/>
              </a:ext>
            </a:extLst>
          </p:cNvPr>
          <p:cNvSpPr txBox="1"/>
          <p:nvPr/>
        </p:nvSpPr>
        <p:spPr>
          <a:xfrm>
            <a:off x="2650653" y="8404742"/>
            <a:ext cx="422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A9C3E1A-18ED-CDFD-9119-F96C6888DC98}"/>
              </a:ext>
            </a:extLst>
          </p:cNvPr>
          <p:cNvSpPr txBox="1"/>
          <p:nvPr/>
        </p:nvSpPr>
        <p:spPr>
          <a:xfrm>
            <a:off x="2568040" y="8054570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F033D77-0685-DDEB-66B8-1D3341DBEA88}"/>
              </a:ext>
            </a:extLst>
          </p:cNvPr>
          <p:cNvSpPr txBox="1"/>
          <p:nvPr/>
        </p:nvSpPr>
        <p:spPr>
          <a:xfrm>
            <a:off x="2568040" y="7712841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B2BDF59-D94F-78F4-A8AA-BC829F644B35}"/>
              </a:ext>
            </a:extLst>
          </p:cNvPr>
          <p:cNvSpPr txBox="1"/>
          <p:nvPr/>
        </p:nvSpPr>
        <p:spPr>
          <a:xfrm>
            <a:off x="2568040" y="7359494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ADCE90D-BC5F-96C2-7A51-AFA8425CA950}"/>
              </a:ext>
            </a:extLst>
          </p:cNvPr>
          <p:cNvSpPr txBox="1"/>
          <p:nvPr/>
        </p:nvSpPr>
        <p:spPr>
          <a:xfrm>
            <a:off x="2568040" y="7015625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DC40808-E658-9A89-6D4F-41228C880A40}"/>
              </a:ext>
            </a:extLst>
          </p:cNvPr>
          <p:cNvSpPr txBox="1"/>
          <p:nvPr/>
        </p:nvSpPr>
        <p:spPr>
          <a:xfrm>
            <a:off x="2568040" y="6674055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EC16A5D-70FD-4B18-C62C-467451087B92}"/>
              </a:ext>
            </a:extLst>
          </p:cNvPr>
          <p:cNvSpPr txBox="1"/>
          <p:nvPr/>
        </p:nvSpPr>
        <p:spPr>
          <a:xfrm>
            <a:off x="2568040" y="6336499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8428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EC33B5BD4E644C4D8D57583994C724B6" ma:contentTypeVersion="15" ma:contentTypeDescription="新しいドキュメントを作成します。" ma:contentTypeScope="" ma:versionID="581ef8f523f6df2d3dcbd90b34743d18">
  <xsd:schema xmlns:xsd="http://www.w3.org/2001/XMLSchema" xmlns:xs="http://www.w3.org/2001/XMLSchema" xmlns:p="http://schemas.microsoft.com/office/2006/metadata/properties" xmlns:ns3="d46048f6-b81f-43a4-8afc-a6570ccfb14b" xmlns:ns4="51e9e23c-c15a-4fef-a277-c63d94d447eb" targetNamespace="http://schemas.microsoft.com/office/2006/metadata/properties" ma:root="true" ma:fieldsID="c1daa78ff8b52bbdaa7f01933a7c6b7a" ns3:_="" ns4:_="">
    <xsd:import namespace="d46048f6-b81f-43a4-8afc-a6570ccfb14b"/>
    <xsd:import namespace="51e9e23c-c15a-4fef-a277-c63d94d447e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46048f6-b81f-43a4-8afc-a6570ccfb14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1e9e23c-c15a-4fef-a277-c63d94d447eb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46048f6-b81f-43a4-8afc-a6570ccfb14b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11CE79A-5FB6-4A5F-AED1-DD9FF18F6BD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46048f6-b81f-43a4-8afc-a6570ccfb14b"/>
    <ds:schemaRef ds:uri="51e9e23c-c15a-4fef-a277-c63d94d447e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4E759A7-835B-42E2-BA5B-EB89C93D1B70}">
  <ds:schemaRefs>
    <ds:schemaRef ds:uri="http://www.w3.org/XML/1998/namespace"/>
    <ds:schemaRef ds:uri="http://purl.org/dc/elements/1.1/"/>
    <ds:schemaRef ds:uri="http://schemas.microsoft.com/office/2006/metadata/properties"/>
    <ds:schemaRef ds:uri="http://schemas.microsoft.com/office/infopath/2007/PartnerControls"/>
    <ds:schemaRef ds:uri="d46048f6-b81f-43a4-8afc-a6570ccfb14b"/>
    <ds:schemaRef ds:uri="51e9e23c-c15a-4fef-a277-c63d94d447eb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ABD4149F-7E02-4E7F-94BF-1A6DE4B3BD6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6</TotalTime>
  <Words>86</Words>
  <Application>Microsoft Office PowerPoint</Application>
  <PresentationFormat>A3 297x420 mm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薬学国試</dc:creator>
  <cp:lastModifiedBy>西田　健太朗</cp:lastModifiedBy>
  <cp:revision>86</cp:revision>
  <cp:lastPrinted>2024-02-26T10:17:30Z</cp:lastPrinted>
  <dcterms:created xsi:type="dcterms:W3CDTF">2022-11-15T04:47:13Z</dcterms:created>
  <dcterms:modified xsi:type="dcterms:W3CDTF">2026-01-09T05:34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C33B5BD4E644C4D8D57583994C724B6</vt:lpwstr>
  </property>
</Properties>
</file>